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72" r:id="rId1"/>
  </p:sldMasterIdLst>
  <p:notesMasterIdLst>
    <p:notesMasterId r:id="rId11"/>
  </p:notesMasterIdLst>
  <p:sldIdLst>
    <p:sldId id="343" r:id="rId2"/>
    <p:sldId id="302" r:id="rId3"/>
    <p:sldId id="313" r:id="rId4"/>
    <p:sldId id="327" r:id="rId5"/>
    <p:sldId id="339" r:id="rId6"/>
    <p:sldId id="337" r:id="rId7"/>
    <p:sldId id="340" r:id="rId8"/>
    <p:sldId id="341" r:id="rId9"/>
    <p:sldId id="342" r:id="rId10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28" userDrawn="1">
          <p15:clr>
            <a:srgbClr val="A4A3A4"/>
          </p15:clr>
        </p15:guide>
        <p15:guide id="2" pos="3144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E99D21D-1054-C422-8A3B-9D69A024076C}" name="Yang, Agnes" initials="AY" userId="S::Yang.Agnes@mayo.edu::a2d0f2bf-e35b-4115-9f44-ebaa3291ebbb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41" autoAdjust="0"/>
    <p:restoredTop sz="96015" autoAdjust="0"/>
  </p:normalViewPr>
  <p:slideViewPr>
    <p:cSldViewPr snapToGrid="0">
      <p:cViewPr varScale="1">
        <p:scale>
          <a:sx n="96" d="100"/>
          <a:sy n="96" d="100"/>
        </p:scale>
        <p:origin x="2712" y="102"/>
      </p:cViewPr>
      <p:guideLst>
        <p:guide orient="horz" pos="528"/>
        <p:guide pos="31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8/10/relationships/authors" Target="author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762540E3-2B3C-4C5B-8DB5-E71F7F4C89FD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D68051D-4CEB-45D8-B99D-1FC6BC241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9887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339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6998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16238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217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0662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135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4729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2152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8271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924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9013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1BA3CAF-8059-4AE1-98A8-4A71A1FC023A}" type="datetimeFigureOut">
              <a:rPr lang="en-US" smtClean="0"/>
              <a:t>3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0C32F03-E76F-46FD-B209-E559A18CDA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04709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3" Type="http://schemas.openxmlformats.org/officeDocument/2006/relationships/image" Target="../media/image13.emf"/><Relationship Id="rId7" Type="http://schemas.openxmlformats.org/officeDocument/2006/relationships/image" Target="../media/image17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emf"/><Relationship Id="rId5" Type="http://schemas.openxmlformats.org/officeDocument/2006/relationships/image" Target="../media/image15.emf"/><Relationship Id="rId4" Type="http://schemas.openxmlformats.org/officeDocument/2006/relationships/image" Target="../media/image14.png"/><Relationship Id="rId9" Type="http://schemas.openxmlformats.org/officeDocument/2006/relationships/image" Target="../media/image19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emf"/><Relationship Id="rId3" Type="http://schemas.openxmlformats.org/officeDocument/2006/relationships/image" Target="../media/image20.emf"/><Relationship Id="rId7" Type="http://schemas.openxmlformats.org/officeDocument/2006/relationships/image" Target="../media/image24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emf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emf"/><Relationship Id="rId3" Type="http://schemas.openxmlformats.org/officeDocument/2006/relationships/image" Target="../media/image26.emf"/><Relationship Id="rId7" Type="http://schemas.openxmlformats.org/officeDocument/2006/relationships/image" Target="../media/image30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emf"/><Relationship Id="rId5" Type="http://schemas.openxmlformats.org/officeDocument/2006/relationships/image" Target="../media/image28.emf"/><Relationship Id="rId4" Type="http://schemas.openxmlformats.org/officeDocument/2006/relationships/image" Target="../media/image27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emf"/><Relationship Id="rId13" Type="http://schemas.openxmlformats.org/officeDocument/2006/relationships/image" Target="../media/image41.emf"/><Relationship Id="rId3" Type="http://schemas.openxmlformats.org/officeDocument/2006/relationships/image" Target="../media/image33.emf"/><Relationship Id="rId7" Type="http://schemas.openxmlformats.org/officeDocument/2006/relationships/image" Target="../media/image35.emf"/><Relationship Id="rId12" Type="http://schemas.openxmlformats.org/officeDocument/2006/relationships/image" Target="../media/image40.emf"/><Relationship Id="rId2" Type="http://schemas.openxmlformats.org/officeDocument/2006/relationships/image" Target="../media/image3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4.emf"/><Relationship Id="rId11" Type="http://schemas.openxmlformats.org/officeDocument/2006/relationships/image" Target="../media/image39.emf"/><Relationship Id="rId5" Type="http://schemas.openxmlformats.org/officeDocument/2006/relationships/image" Target="../media/image13.emf"/><Relationship Id="rId10" Type="http://schemas.openxmlformats.org/officeDocument/2006/relationships/image" Target="../media/image38.emf"/><Relationship Id="rId4" Type="http://schemas.openxmlformats.org/officeDocument/2006/relationships/image" Target="../media/image12.emf"/><Relationship Id="rId9" Type="http://schemas.openxmlformats.org/officeDocument/2006/relationships/image" Target="../media/image37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5.emf"/><Relationship Id="rId5" Type="http://schemas.openxmlformats.org/officeDocument/2006/relationships/image" Target="../media/image44.emf"/><Relationship Id="rId4" Type="http://schemas.openxmlformats.org/officeDocument/2006/relationships/image" Target="../media/image43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9.emf"/><Relationship Id="rId5" Type="http://schemas.openxmlformats.org/officeDocument/2006/relationships/image" Target="../media/image48.emf"/><Relationship Id="rId4" Type="http://schemas.openxmlformats.org/officeDocument/2006/relationships/image" Target="../media/image47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emf"/><Relationship Id="rId5" Type="http://schemas.openxmlformats.org/officeDocument/2006/relationships/image" Target="../media/image52.emf"/><Relationship Id="rId4" Type="http://schemas.openxmlformats.org/officeDocument/2006/relationships/image" Target="../media/image5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9208D66-806F-3A1E-6DA3-617C6BC5FD5A}"/>
              </a:ext>
            </a:extLst>
          </p:cNvPr>
          <p:cNvSpPr txBox="1"/>
          <p:nvPr/>
        </p:nvSpPr>
        <p:spPr>
          <a:xfrm>
            <a:off x="509048" y="641601"/>
            <a:ext cx="18806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s for: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23A5AA0-7803-6977-6905-263932FA89F1}"/>
              </a:ext>
            </a:extLst>
          </p:cNvPr>
          <p:cNvSpPr txBox="1"/>
          <p:nvPr/>
        </p:nvSpPr>
        <p:spPr>
          <a:xfrm>
            <a:off x="366173" y="1135919"/>
            <a:ext cx="616513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Omalizumab controls surface phenotypes of dendritic cells and monocytes in asthm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B6923E2-C7B2-F931-7155-B2B0A14CFFD0}"/>
              </a:ext>
            </a:extLst>
          </p:cNvPr>
          <p:cNvSpPr txBox="1"/>
          <p:nvPr/>
        </p:nvSpPr>
        <p:spPr>
          <a:xfrm>
            <a:off x="509048" y="2321485"/>
            <a:ext cx="5733313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</a:pP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*AY, LB, and KU equally contribute to this study</a:t>
            </a:r>
            <a:endParaRPr lang="en-US" sz="1200" kern="1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endParaRPr lang="en-US" sz="1200" kern="1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kern="100" baseline="30000" dirty="0">
                <a:solidFill>
                  <a:srgbClr val="000000"/>
                </a:solidFill>
                <a:effectLst/>
                <a:latin typeface="Times" panose="02020603050405020304" pitchFamily="18" charset="0"/>
                <a:ea typeface="Arial Unicode MS"/>
                <a:cs typeface="Times New Roman" panose="02020603050405020304" pitchFamily="18" charset="0"/>
              </a:rPr>
              <a:t>1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Times" panose="02020603050405020304" pitchFamily="18" charset="0"/>
                <a:ea typeface="Arial Unicode MS"/>
                <a:cs typeface="Times New Roman" panose="02020603050405020304" pitchFamily="18" charset="0"/>
              </a:rPr>
              <a:t>Department of Immunology, Mayo Clinic, Scottsdale, AZ</a:t>
            </a:r>
            <a:endParaRPr lang="en-US" sz="1200" kern="1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kern="100" baseline="30000" dirty="0">
                <a:solidFill>
                  <a:srgbClr val="000000"/>
                </a:solidFill>
                <a:effectLst/>
                <a:latin typeface="Times" panose="02020603050405020304" pitchFamily="18" charset="0"/>
                <a:ea typeface="Arial Unicode MS"/>
                <a:cs typeface="Times New Roman" panose="02020603050405020304" pitchFamily="18" charset="0"/>
              </a:rPr>
              <a:t>2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Times" panose="02020603050405020304" pitchFamily="18" charset="0"/>
                <a:ea typeface="Arial Unicode MS"/>
                <a:cs typeface="Times New Roman" panose="02020603050405020304" pitchFamily="18" charset="0"/>
              </a:rPr>
              <a:t>Baylor University, Institute for Biomedical Studies, Waco, TX </a:t>
            </a:r>
            <a:endParaRPr lang="en-US" sz="1200" kern="1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kern="100" baseline="30000" dirty="0">
                <a:solidFill>
                  <a:srgbClr val="000000"/>
                </a:solidFill>
                <a:effectLst/>
                <a:latin typeface="Times" panose="02020603050405020304" pitchFamily="18" charset="0"/>
                <a:ea typeface="Arial Unicode MS"/>
                <a:cs typeface="Times New Roman" panose="02020603050405020304" pitchFamily="18" charset="0"/>
              </a:rPr>
              <a:t>3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Times" panose="02020603050405020304" pitchFamily="18" charset="0"/>
                <a:ea typeface="Arial Unicode MS"/>
                <a:cs typeface="Times New Roman" panose="02020603050405020304" pitchFamily="18" charset="0"/>
              </a:rPr>
              <a:t>Martha Foster Lung Care Center, Baylor University Medical Center, Dallas, TX </a:t>
            </a:r>
            <a:endParaRPr lang="en-US" sz="1200" kern="1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AC3D117-4617-516F-95A9-DAEB5E676479}"/>
              </a:ext>
            </a:extLst>
          </p:cNvPr>
          <p:cNvSpPr txBox="1"/>
          <p:nvPr/>
        </p:nvSpPr>
        <p:spPr>
          <a:xfrm>
            <a:off x="509048" y="1886903"/>
            <a:ext cx="583990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Agnes Yang, BS</a:t>
            </a:r>
            <a:r>
              <a:rPr lang="en-US" sz="12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*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Laurie Baert, PhD</a:t>
            </a:r>
            <a:r>
              <a:rPr lang="en-US" sz="12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*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Katherine Upchurch, PhD</a:t>
            </a:r>
            <a:r>
              <a:rPr lang="en-US" sz="12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2*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Mark Millard, MD</a:t>
            </a:r>
            <a:r>
              <a:rPr lang="en-US" sz="12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3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Matthew Wiest</a:t>
            </a:r>
            <a:r>
              <a:rPr lang="en-US" sz="120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, PhD</a:t>
            </a:r>
            <a:r>
              <a:rPr lang="en-US" sz="1200" baseline="30000">
                <a:solidFill>
                  <a:srgbClr val="000000"/>
                </a:solidFill>
                <a:effectLst/>
                <a:latin typeface="Times" panose="02020603050405020304" pitchFamily="18" charset="0"/>
                <a:ea typeface="Arial Unicode MS"/>
                <a:cs typeface="Times New Roman" panose="02020603050405020304" pitchFamily="18" charset="0"/>
              </a:rPr>
              <a:t>1</a:t>
            </a:r>
            <a:r>
              <a:rPr lang="en-US" sz="1200" kern="100" baseline="3000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</a:t>
            </a:r>
            <a:r>
              <a:rPr lang="en-US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sz="1200" kern="10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hao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u, PhD</a:t>
            </a:r>
            <a:r>
              <a:rPr lang="en-US" sz="12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HyeMee Joo, PhD</a:t>
            </a:r>
            <a:r>
              <a:rPr lang="en-US" sz="12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and SangKon Oh, PhD</a:t>
            </a:r>
            <a:r>
              <a:rPr lang="en-US" sz="12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, 2</a:t>
            </a:r>
            <a:endParaRPr lang="en-US" sz="1200" kern="100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D0595165-2A27-C339-A170-1FA36914E79B}"/>
              </a:ext>
            </a:extLst>
          </p:cNvPr>
          <p:cNvGraphicFramePr>
            <a:graphicFrameLocks noGrp="1"/>
          </p:cNvGraphicFramePr>
          <p:nvPr/>
        </p:nvGraphicFramePr>
        <p:xfrm>
          <a:off x="537623" y="3762375"/>
          <a:ext cx="5876189" cy="492315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74725">
                  <a:extLst>
                    <a:ext uri="{9D8B030D-6E8A-4147-A177-3AD203B41FA5}">
                      <a16:colId xmlns:a16="http://schemas.microsoft.com/office/drawing/2014/main" val="3532298759"/>
                    </a:ext>
                  </a:extLst>
                </a:gridCol>
                <a:gridCol w="5101464">
                  <a:extLst>
                    <a:ext uri="{9D8B030D-6E8A-4147-A177-3AD203B41FA5}">
                      <a16:colId xmlns:a16="http://schemas.microsoft.com/office/drawing/2014/main" val="4185052639"/>
                    </a:ext>
                  </a:extLst>
                </a:gridCol>
              </a:tblGrid>
              <a:tr h="430234">
                <a:tc gridSpan="2">
                  <a:txBody>
                    <a:bodyPr/>
                    <a:lstStyle/>
                    <a:p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is Supplemental Information includes:</a:t>
                      </a:r>
                    </a:p>
                    <a:p>
                      <a:endParaRPr 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28103241"/>
                  </a:ext>
                </a:extLst>
              </a:tr>
              <a:tr h="430234">
                <a:tc>
                  <a:txBody>
                    <a:bodyPr/>
                    <a:lstStyle/>
                    <a:p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. E1.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Aptos" panose="020B0004020202020204" pitchFamily="34" charset="0"/>
                          <a:cs typeface="+mn-cs"/>
                        </a:rPr>
                        <a:t>Asthma patients and non-asthmatic control subjects have similar frequency of CD141</a:t>
                      </a:r>
                      <a:r>
                        <a:rPr kumimoji="0" lang="en-US" sz="12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Aptos" panose="020B0004020202020204" pitchFamily="34" charset="0"/>
                          <a:cs typeface="+mn-cs"/>
                        </a:rPr>
                        <a:t>+</a:t>
                      </a:r>
                      <a:r>
                        <a:rPr kumimoji="0" 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Aptos" panose="020B0004020202020204" pitchFamily="34" charset="0"/>
                          <a:cs typeface="+mn-cs"/>
                        </a:rPr>
                        <a:t> </a:t>
                      </a:r>
                      <a:r>
                        <a:rPr kumimoji="0" lang="en-US" sz="12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Aptos" panose="020B0004020202020204" pitchFamily="34" charset="0"/>
                          <a:cs typeface="+mn-cs"/>
                        </a:rPr>
                        <a:t>mDCs</a:t>
                      </a:r>
                      <a:r>
                        <a:rPr kumimoji="0" 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Aptos" panose="020B0004020202020204" pitchFamily="34" charset="0"/>
                          <a:cs typeface="+mn-cs"/>
                        </a:rPr>
                        <a:t> in their blood. 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8942063"/>
                  </a:ext>
                </a:extLst>
              </a:tr>
              <a:tr h="43023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. E2.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Omalizumab treatment decreases </a:t>
                      </a: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mDC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pDC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rati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o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overtime by increasing the frequency of blood circulating </a:t>
                      </a: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pDCs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. 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25454868"/>
                  </a:ext>
                </a:extLst>
              </a:tr>
              <a:tr h="43023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. E3.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Omalizumab reduces surface expression levels of </a:t>
                      </a: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FcɛRI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, as well as HLA-DR, CCR7, and costimulatory molecules on </a:t>
                      </a: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mDCs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.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4426453"/>
                  </a:ext>
                </a:extLst>
              </a:tr>
              <a:tr h="43023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. E4.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Omalizumab treatment decreases surface expression levels of </a:t>
                      </a: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FcɛRI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, as well as HLA-DR, CCR7, and costimulatory molecules on </a:t>
                      </a: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pDCs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.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0370363"/>
                  </a:ext>
                </a:extLst>
              </a:tr>
              <a:tr h="2581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. E5.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Asthma patients have increased numbers of blood circulating CD14</a:t>
                      </a:r>
                      <a:r>
                        <a:rPr lang="en-US" sz="1200" kern="1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monocytes. 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6534648"/>
                  </a:ext>
                </a:extLst>
              </a:tr>
              <a:tr h="43023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. E6.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Omalizumab decreases surface expression levels of </a:t>
                      </a: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FcɛRI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, as well as CCR7, HLA-DR, and CD88 on CD14</a:t>
                      </a:r>
                      <a:r>
                        <a:rPr lang="en-US" sz="1200" kern="1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CD16</a:t>
                      </a:r>
                      <a:r>
                        <a:rPr lang="en-US" sz="1200" kern="1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 blood monocyte in asthma patients. 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7793936"/>
                  </a:ext>
                </a:extLst>
              </a:tr>
              <a:tr h="43023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. E7.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Omalizumab decreases surface expression levels of </a:t>
                      </a: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FcɛRI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, as well as CCR7, HLA-DR, and CD88 on CD14</a:t>
                      </a:r>
                      <a:r>
                        <a:rPr lang="en-US" sz="1200" kern="1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CD16</a:t>
                      </a:r>
                      <a:r>
                        <a:rPr lang="en-US" sz="1200" kern="1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 blood monocyte in asthma patients. 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9806902"/>
                  </a:ext>
                </a:extLst>
              </a:tr>
              <a:tr h="43023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. E8.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Omalizumab decreases surface expression levels of 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HLA-DR and CD88 on CD14</a:t>
                      </a:r>
                      <a:r>
                        <a:rPr lang="en-US" sz="1200" kern="1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dim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CD16</a:t>
                      </a:r>
                      <a:r>
                        <a:rPr lang="en-US" sz="1200" kern="1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 blood monocyte in asthma patients.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6490583"/>
                  </a:ext>
                </a:extLst>
              </a:tr>
              <a:tr h="40417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/>
                      <a:endParaRPr lang="en-US" sz="1400" kern="1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6648439"/>
                  </a:ext>
                </a:extLst>
              </a:tr>
              <a:tr h="40417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/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7282902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30200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7" name="Group 76">
            <a:extLst>
              <a:ext uri="{FF2B5EF4-FFF2-40B4-BE49-F238E27FC236}">
                <a16:creationId xmlns:a16="http://schemas.microsoft.com/office/drawing/2014/main" id="{DC9592F7-DC37-D7BD-0E06-5C17DA47E6CC}"/>
              </a:ext>
            </a:extLst>
          </p:cNvPr>
          <p:cNvGrpSpPr/>
          <p:nvPr/>
        </p:nvGrpSpPr>
        <p:grpSpPr>
          <a:xfrm>
            <a:off x="538078" y="770874"/>
            <a:ext cx="5333884" cy="1229030"/>
            <a:chOff x="314376" y="4700081"/>
            <a:chExt cx="8290696" cy="1684917"/>
          </a:xfrm>
        </p:grpSpPr>
        <p:pic>
          <p:nvPicPr>
            <p:cNvPr id="78" name="Picture 77">
              <a:extLst>
                <a:ext uri="{FF2B5EF4-FFF2-40B4-BE49-F238E27FC236}">
                  <a16:creationId xmlns:a16="http://schemas.microsoft.com/office/drawing/2014/main" id="{D8792E95-EF63-0EA8-B1F2-0C25B363AF9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57123" y="4710379"/>
              <a:ext cx="1457964" cy="1366842"/>
            </a:xfrm>
            <a:prstGeom prst="rect">
              <a:avLst/>
            </a:prstGeom>
          </p:spPr>
        </p:pic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AC5FF162-797A-8B09-E79D-9B592DF05381}"/>
                </a:ext>
              </a:extLst>
            </p:cNvPr>
            <p:cNvSpPr txBox="1"/>
            <p:nvPr/>
          </p:nvSpPr>
          <p:spPr>
            <a:xfrm>
              <a:off x="1095393" y="6077221"/>
              <a:ext cx="60785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FSC-A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99A2510F-EC23-E309-BF80-C151ABBDF389}"/>
                </a:ext>
              </a:extLst>
            </p:cNvPr>
            <p:cNvSpPr txBox="1"/>
            <p:nvPr/>
          </p:nvSpPr>
          <p:spPr>
            <a:xfrm rot="16200000">
              <a:off x="128773" y="5214010"/>
              <a:ext cx="654492" cy="283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SSC-A</a:t>
              </a:r>
            </a:p>
          </p:txBody>
        </p:sp>
        <p:pic>
          <p:nvPicPr>
            <p:cNvPr id="81" name="Picture 80">
              <a:extLst>
                <a:ext uri="{FF2B5EF4-FFF2-40B4-BE49-F238E27FC236}">
                  <a16:creationId xmlns:a16="http://schemas.microsoft.com/office/drawing/2014/main" id="{C1FB4367-C486-A8B8-2E70-EFDFF94187B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208841" y="4710379"/>
              <a:ext cx="1457965" cy="1366842"/>
            </a:xfrm>
            <a:prstGeom prst="rect">
              <a:avLst/>
            </a:prstGeom>
          </p:spPr>
        </p:pic>
        <p:pic>
          <p:nvPicPr>
            <p:cNvPr id="82" name="Picture 81">
              <a:extLst>
                <a:ext uri="{FF2B5EF4-FFF2-40B4-BE49-F238E27FC236}">
                  <a16:creationId xmlns:a16="http://schemas.microsoft.com/office/drawing/2014/main" id="{B376B5A8-2ECB-ECA4-6A5A-DCE043203E6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878511" y="4700081"/>
              <a:ext cx="1406131" cy="1377139"/>
            </a:xfrm>
            <a:prstGeom prst="rect">
              <a:avLst/>
            </a:prstGeom>
          </p:spPr>
        </p:pic>
        <p:pic>
          <p:nvPicPr>
            <p:cNvPr id="83" name="Picture 82">
              <a:extLst>
                <a:ext uri="{FF2B5EF4-FFF2-40B4-BE49-F238E27FC236}">
                  <a16:creationId xmlns:a16="http://schemas.microsoft.com/office/drawing/2014/main" id="{2D9DDDE4-DBC9-A354-DCCE-01C0E933E8D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530440" y="4700081"/>
              <a:ext cx="1406131" cy="1377139"/>
            </a:xfrm>
            <a:prstGeom prst="rect">
              <a:avLst/>
            </a:prstGeom>
          </p:spPr>
        </p:pic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B738D6E5-E65A-0610-48BE-BF369B5FFF32}"/>
                </a:ext>
              </a:extLst>
            </p:cNvPr>
            <p:cNvSpPr txBox="1"/>
            <p:nvPr/>
          </p:nvSpPr>
          <p:spPr>
            <a:xfrm>
              <a:off x="2722924" y="6077220"/>
              <a:ext cx="60785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FSC-A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1EBFBFAF-5C45-1330-FC06-5949B79E1B35}"/>
                </a:ext>
              </a:extLst>
            </p:cNvPr>
            <p:cNvSpPr txBox="1"/>
            <p:nvPr/>
          </p:nvSpPr>
          <p:spPr>
            <a:xfrm rot="16200000">
              <a:off x="1795721" y="5211836"/>
              <a:ext cx="665731" cy="283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FSC-H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DBE43637-56C5-4B08-B839-AC8C348967E7}"/>
                </a:ext>
              </a:extLst>
            </p:cNvPr>
            <p:cNvSpPr txBox="1"/>
            <p:nvPr/>
          </p:nvSpPr>
          <p:spPr>
            <a:xfrm>
              <a:off x="4357452" y="6077220"/>
              <a:ext cx="48666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Lin1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BAA15EE7-1919-7E74-E19D-07D217D136FF}"/>
                </a:ext>
              </a:extLst>
            </p:cNvPr>
            <p:cNvSpPr txBox="1"/>
            <p:nvPr/>
          </p:nvSpPr>
          <p:spPr>
            <a:xfrm rot="16200000">
              <a:off x="3386495" y="5238510"/>
              <a:ext cx="753386" cy="283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HLA-DR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486710FF-2B2B-10E2-2A15-881B757D03B7}"/>
                </a:ext>
              </a:extLst>
            </p:cNvPr>
            <p:cNvSpPr txBox="1"/>
            <p:nvPr/>
          </p:nvSpPr>
          <p:spPr>
            <a:xfrm rot="16200000">
              <a:off x="5076560" y="5225836"/>
              <a:ext cx="685958" cy="283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CD123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470E18F0-18B0-5074-4BE4-960878393875}"/>
                </a:ext>
              </a:extLst>
            </p:cNvPr>
            <p:cNvSpPr txBox="1"/>
            <p:nvPr/>
          </p:nvSpPr>
          <p:spPr>
            <a:xfrm>
              <a:off x="5954793" y="6077220"/>
              <a:ext cx="6487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CD11c</a:t>
              </a:r>
            </a:p>
          </p:txBody>
        </p:sp>
        <p:pic>
          <p:nvPicPr>
            <p:cNvPr id="90" name="Picture 89">
              <a:extLst>
                <a:ext uri="{FF2B5EF4-FFF2-40B4-BE49-F238E27FC236}">
                  <a16:creationId xmlns:a16="http://schemas.microsoft.com/office/drawing/2014/main" id="{AC17D1B2-831C-7C15-BEEB-8C4AF9D36CC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153261" y="4710379"/>
              <a:ext cx="1451811" cy="1379220"/>
            </a:xfrm>
            <a:prstGeom prst="rect">
              <a:avLst/>
            </a:prstGeom>
          </p:spPr>
        </p:pic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8E0A0532-7E68-1F0A-6623-557D3C5E7586}"/>
                </a:ext>
              </a:extLst>
            </p:cNvPr>
            <p:cNvSpPr txBox="1"/>
            <p:nvPr/>
          </p:nvSpPr>
          <p:spPr>
            <a:xfrm rot="16200000">
              <a:off x="6712750" y="5228768"/>
              <a:ext cx="654492" cy="283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SSC-A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CAE9A8EB-AE29-6D95-F25E-BC9C81E6DCE8}"/>
                </a:ext>
              </a:extLst>
            </p:cNvPr>
            <p:cNvSpPr txBox="1"/>
            <p:nvPr/>
          </p:nvSpPr>
          <p:spPr>
            <a:xfrm>
              <a:off x="7663909" y="6077221"/>
              <a:ext cx="6638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CD141</a:t>
              </a:r>
            </a:p>
          </p:txBody>
        </p:sp>
      </p:grpSp>
      <p:pic>
        <p:nvPicPr>
          <p:cNvPr id="15" name="Picture 14">
            <a:extLst>
              <a:ext uri="{FF2B5EF4-FFF2-40B4-BE49-F238E27FC236}">
                <a16:creationId xmlns:a16="http://schemas.microsoft.com/office/drawing/2014/main" id="{5E11333B-DF0F-E809-C22D-177805F8320E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61883" t="14875" b="62625"/>
          <a:stretch/>
        </p:blipFill>
        <p:spPr>
          <a:xfrm>
            <a:off x="2346879" y="2131405"/>
            <a:ext cx="996396" cy="39090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B871609-803B-B7A9-A2C5-8D2D77A81E44}"/>
              </a:ext>
            </a:extLst>
          </p:cNvPr>
          <p:cNvSpPr txBox="1"/>
          <p:nvPr/>
        </p:nvSpPr>
        <p:spPr>
          <a:xfrm>
            <a:off x="342900" y="5975134"/>
            <a:ext cx="6172200" cy="16158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Fig E1.</a:t>
            </a:r>
            <a:r>
              <a:rPr lang="en-US" sz="1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Asthma patients and non-asthmatic control subjects have similar frequency of CD141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+</a:t>
            </a:r>
            <a:r>
              <a:rPr lang="en-US" sz="1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mDCs</a:t>
            </a:r>
            <a:r>
              <a:rPr lang="en-US" sz="1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in their blood. </a:t>
            </a:r>
            <a:r>
              <a:rPr lang="en-US" sz="1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Gating strategy for DC subsets, including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ea typeface="Malgun Gothic" panose="020B0503020000020004" pitchFamily="34" charset="-127"/>
              </a:rPr>
              <a:t>mDCs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 (Lin-1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-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, HLA-DR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+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, CD123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-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, CD11c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+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), </a:t>
            </a:r>
            <a:r>
              <a:rPr lang="en-US" sz="1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CD141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+</a:t>
            </a:r>
            <a:r>
              <a:rPr lang="en-US" sz="1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mDCs</a:t>
            </a:r>
            <a:r>
              <a:rPr lang="en-US" sz="1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, 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(Lin-1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-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, HLA-DR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+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, CD123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-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, CD11c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+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, CD141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+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) and </a:t>
            </a:r>
            <a:r>
              <a:rPr lang="en-US" sz="1100" dirty="0" err="1">
                <a:latin typeface="Times New Roman" panose="02020603050405020304" pitchFamily="18" charset="0"/>
                <a:ea typeface="Malgun Gothic" panose="020B0503020000020004" pitchFamily="34" charset="-127"/>
              </a:rPr>
              <a:t>pDCs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 (Lin-1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-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, HLA-DR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+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, CD123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+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, CD11c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-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)</a:t>
            </a:r>
            <a:r>
              <a:rPr lang="en-US" sz="1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 in whole blood staining </a:t>
            </a:r>
            <a:r>
              <a:rPr lang="en-US" sz="1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(A)</a:t>
            </a:r>
            <a:r>
              <a:rPr lang="en-US" sz="1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. </a:t>
            </a:r>
            <a:r>
              <a:rPr lang="en-US" sz="1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The percentage (B) and number (C) of CD141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+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mDCs</a:t>
            </a:r>
            <a:r>
              <a:rPr lang="en-US" sz="1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per </a:t>
            </a:r>
            <a:r>
              <a:rPr lang="en-US" sz="1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sz="1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L</a:t>
            </a:r>
            <a:r>
              <a:rPr lang="en-US" sz="1100" dirty="0">
                <a:latin typeface="Times New Roman" panose="02020603050405020304" pitchFamily="18" charset="0"/>
                <a:ea typeface="Aptos" panose="020B0004020202020204" pitchFamily="34" charset="0"/>
              </a:rPr>
              <a:t> </a:t>
            </a:r>
            <a:r>
              <a:rPr lang="en-US" sz="1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of whole blood from asthma patients and non-asthmatic control subjects at baseline (left panels), as well as those in omalizumab responders and non-responders at baseline and week 26 (right panels). Mann-Whitney U test and Wilcoxon matched-pairs signed rank test were used for left and right panels, respectively, in B-C. Data for non-asthmatic control subjects and asthma patients are expressed as mean ± SD.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n.s</a:t>
            </a:r>
            <a:r>
              <a:rPr lang="en-US" sz="11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.: not significant. </a:t>
            </a:r>
            <a:endParaRPr lang="en-US" sz="11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1A6B597-587A-E0D9-02F8-0A9B14B95479}"/>
              </a:ext>
            </a:extLst>
          </p:cNvPr>
          <p:cNvSpPr txBox="1"/>
          <p:nvPr/>
        </p:nvSpPr>
        <p:spPr>
          <a:xfrm>
            <a:off x="424619" y="2320271"/>
            <a:ext cx="2680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5A1A0A1-6EF2-537B-6E00-04209039DC19}"/>
              </a:ext>
            </a:extLst>
          </p:cNvPr>
          <p:cNvSpPr txBox="1"/>
          <p:nvPr/>
        </p:nvSpPr>
        <p:spPr>
          <a:xfrm>
            <a:off x="425235" y="491886"/>
            <a:ext cx="2680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A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5B567FD4-A674-B7CD-AF19-324CE8D7E0F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3386" y="4148656"/>
            <a:ext cx="280440" cy="286537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F096292-2A4B-FD43-C32A-27BDD407F4B3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24314"/>
          <a:stretch/>
        </p:blipFill>
        <p:spPr>
          <a:xfrm>
            <a:off x="2332461" y="2221658"/>
            <a:ext cx="1391814" cy="173736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37CBEDF7-CCE4-B93F-0096-80FD520CB911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l="19704"/>
          <a:stretch/>
        </p:blipFill>
        <p:spPr>
          <a:xfrm>
            <a:off x="2332461" y="4140632"/>
            <a:ext cx="1386434" cy="173736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5A51545-4B21-7E51-1725-D32E191175A0}"/>
              </a:ext>
            </a:extLst>
          </p:cNvPr>
          <p:cNvSpPr txBox="1"/>
          <p:nvPr/>
        </p:nvSpPr>
        <p:spPr>
          <a:xfrm>
            <a:off x="4122416" y="724529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DCs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E5DF08C-C277-8EE7-2B59-BB1E1BECB8EB}"/>
              </a:ext>
            </a:extLst>
          </p:cNvPr>
          <p:cNvSpPr txBox="1"/>
          <p:nvPr/>
        </p:nvSpPr>
        <p:spPr>
          <a:xfrm>
            <a:off x="4388605" y="913999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DCs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D15DA3-F480-6A56-37F6-B7ED31048754}"/>
              </a:ext>
            </a:extLst>
          </p:cNvPr>
          <p:cNvSpPr txBox="1"/>
          <p:nvPr/>
        </p:nvSpPr>
        <p:spPr>
          <a:xfrm>
            <a:off x="5664968" y="1441559"/>
            <a:ext cx="8851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41</a:t>
            </a:r>
            <a:r>
              <a:rPr lang="en-US" sz="9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DCs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9AB7601C-994F-B360-FAAE-F31E2109E361}"/>
              </a:ext>
            </a:extLst>
          </p:cNvPr>
          <p:cNvCxnSpPr>
            <a:cxnSpLocks/>
          </p:cNvCxnSpPr>
          <p:nvPr/>
        </p:nvCxnSpPr>
        <p:spPr>
          <a:xfrm>
            <a:off x="1626394" y="1446846"/>
            <a:ext cx="388142" cy="0"/>
          </a:xfrm>
          <a:prstGeom prst="straightConnector1">
            <a:avLst/>
          </a:prstGeom>
          <a:ln w="952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D8AFB65F-3AD0-C1FB-030B-4ED3425B8142}"/>
              </a:ext>
            </a:extLst>
          </p:cNvPr>
          <p:cNvCxnSpPr>
            <a:cxnSpLocks/>
          </p:cNvCxnSpPr>
          <p:nvPr/>
        </p:nvCxnSpPr>
        <p:spPr>
          <a:xfrm>
            <a:off x="2437885" y="1541711"/>
            <a:ext cx="388142" cy="0"/>
          </a:xfrm>
          <a:prstGeom prst="straightConnector1">
            <a:avLst/>
          </a:prstGeom>
          <a:ln w="952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F8A7BA5E-15B5-EDFE-70FF-87462BB07A82}"/>
              </a:ext>
            </a:extLst>
          </p:cNvPr>
          <p:cNvCxnSpPr>
            <a:cxnSpLocks/>
          </p:cNvCxnSpPr>
          <p:nvPr/>
        </p:nvCxnSpPr>
        <p:spPr>
          <a:xfrm>
            <a:off x="4640158" y="1324771"/>
            <a:ext cx="298973" cy="174149"/>
          </a:xfrm>
          <a:prstGeom prst="straightConnector1">
            <a:avLst/>
          </a:prstGeom>
          <a:ln w="952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6801121F-AA46-993B-FF03-AC302D4B61A4}"/>
              </a:ext>
            </a:extLst>
          </p:cNvPr>
          <p:cNvCxnSpPr>
            <a:cxnSpLocks/>
          </p:cNvCxnSpPr>
          <p:nvPr/>
        </p:nvCxnSpPr>
        <p:spPr>
          <a:xfrm>
            <a:off x="3493868" y="914928"/>
            <a:ext cx="411954" cy="0"/>
          </a:xfrm>
          <a:prstGeom prst="straightConnector1">
            <a:avLst/>
          </a:prstGeom>
          <a:ln w="952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11" name="Picture 10">
            <a:extLst>
              <a:ext uri="{FF2B5EF4-FFF2-40B4-BE49-F238E27FC236}">
                <a16:creationId xmlns:a16="http://schemas.microsoft.com/office/drawing/2014/main" id="{9814300F-6AAC-EA38-262F-30DEADFEB39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64291" y="2228960"/>
            <a:ext cx="1940767" cy="18288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8A1BEB0A-CCDF-9607-1F42-E81CE50CA9F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75555" y="4147795"/>
            <a:ext cx="1834132" cy="18288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53DC6794-809C-3FA9-7D24-22A9F9B84865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61883" t="14875" b="62625"/>
          <a:stretch/>
        </p:blipFill>
        <p:spPr>
          <a:xfrm>
            <a:off x="2346879" y="4048017"/>
            <a:ext cx="996396" cy="3909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0483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BDC7BA4A-AF63-1FCC-EE26-EDD64F39DB3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70785" t="17424" b="64894"/>
          <a:stretch/>
        </p:blipFill>
        <p:spPr>
          <a:xfrm>
            <a:off x="3156085" y="698572"/>
            <a:ext cx="1066853" cy="362529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78D3EA6F-39F0-A864-1358-72DE0782D00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9692" t="24384" b="63150"/>
          <a:stretch/>
        </p:blipFill>
        <p:spPr>
          <a:xfrm>
            <a:off x="1951374" y="849440"/>
            <a:ext cx="1070855" cy="23934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1EF9F52F-27AB-EFC9-FA11-0A829B3B641B}"/>
              </a:ext>
            </a:extLst>
          </p:cNvPr>
          <p:cNvSpPr txBox="1"/>
          <p:nvPr/>
        </p:nvSpPr>
        <p:spPr>
          <a:xfrm>
            <a:off x="342900" y="6365585"/>
            <a:ext cx="6172200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</a:pPr>
            <a:r>
              <a:rPr lang="en-US" sz="11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 E2.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Omalizumab treatment decreases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DC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/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DC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rati</a:t>
            </a:r>
            <a:r>
              <a:rPr lang="en-US" sz="11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o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overtime by increasing the frequency of blood circulating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DCs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The frequency of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DCs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(Lin-1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-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HLA-DR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+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CD123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+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CD11c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-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)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in whole blood (A) and the number of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DCs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per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L of whole blood (B) were assessed by flow cytometry at indicated time points. The ratios of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DC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/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DC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1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C)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re presented. Data of all asthma patients (left panels) and those of omalizumab responders versus non-responders (right panels) are presented. Wilcoxon matched-pairs signed rank test was used. Data are expressed as Tukey-style box plots, with boxes binding IQR divided by the median. *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&lt; 0.05, **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&lt; 0.01, ***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&lt; 0.001, ****P&lt;0.0001, and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n.s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: not significant. </a:t>
            </a:r>
            <a:endParaRPr lang="en-US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0F26FF7-E06D-A467-4D54-1563899431EC}"/>
              </a:ext>
            </a:extLst>
          </p:cNvPr>
          <p:cNvSpPr txBox="1"/>
          <p:nvPr/>
        </p:nvSpPr>
        <p:spPr>
          <a:xfrm>
            <a:off x="1235923" y="2693642"/>
            <a:ext cx="2680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7D5FED5-0013-DFC2-E6E4-30A0BF94B7F4}"/>
              </a:ext>
            </a:extLst>
          </p:cNvPr>
          <p:cNvSpPr txBox="1"/>
          <p:nvPr/>
        </p:nvSpPr>
        <p:spPr>
          <a:xfrm>
            <a:off x="1253557" y="4683150"/>
            <a:ext cx="2792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C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4197658-4A1A-0148-E246-7B85EA2A7E38}"/>
              </a:ext>
            </a:extLst>
          </p:cNvPr>
          <p:cNvSpPr txBox="1"/>
          <p:nvPr/>
        </p:nvSpPr>
        <p:spPr>
          <a:xfrm>
            <a:off x="1247145" y="704134"/>
            <a:ext cx="2680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A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9321B489-11D2-29D7-1FAE-6D23C9B6E8B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63238" y="948877"/>
            <a:ext cx="1794680" cy="16002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4671931D-7420-CAEC-6404-BBB05248C945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2789" r="28047"/>
          <a:stretch/>
        </p:blipFill>
        <p:spPr>
          <a:xfrm>
            <a:off x="3151523" y="792683"/>
            <a:ext cx="1824883" cy="173736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FCADE8AA-9B65-7D1D-0E1D-BEDDE763C579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0317" r="29785"/>
          <a:stretch/>
        </p:blipFill>
        <p:spPr>
          <a:xfrm>
            <a:off x="3145174" y="2729266"/>
            <a:ext cx="1805048" cy="173736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F78384C0-5273-FEB6-1336-BF339F1B8FA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47779" y="4639925"/>
            <a:ext cx="1726636" cy="173736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C6412140-275D-EFFF-37E5-D58CB431C2DC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10565" r="30821"/>
          <a:stretch/>
        </p:blipFill>
        <p:spPr>
          <a:xfrm>
            <a:off x="3151524" y="4604256"/>
            <a:ext cx="1812324" cy="18288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1A19316-D5A3-F793-678D-AF998114CCB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516904" y="2725821"/>
            <a:ext cx="1838929" cy="173736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A80AF42-94AF-EE76-B42D-88DBF3E9981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70785" t="17424" b="64894"/>
          <a:stretch/>
        </p:blipFill>
        <p:spPr>
          <a:xfrm>
            <a:off x="3154108" y="2611336"/>
            <a:ext cx="1066853" cy="362529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1065A7D5-72D3-A00E-243B-664790FF402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9692" t="25656" b="63150"/>
          <a:stretch/>
        </p:blipFill>
        <p:spPr>
          <a:xfrm>
            <a:off x="1949397" y="2786612"/>
            <a:ext cx="1070855" cy="214935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78FF7B0C-97DF-F72E-F38F-ADD77088C97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70785" t="17424" b="64894"/>
          <a:stretch/>
        </p:blipFill>
        <p:spPr>
          <a:xfrm>
            <a:off x="3152131" y="4542085"/>
            <a:ext cx="1066853" cy="362529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8FBB1ED7-ABC5-0D9F-1A3E-D2DD3166801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9692" t="26464" b="63150"/>
          <a:stretch/>
        </p:blipFill>
        <p:spPr>
          <a:xfrm>
            <a:off x="1947420" y="4732883"/>
            <a:ext cx="1070855" cy="199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89026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48">
            <a:extLst>
              <a:ext uri="{FF2B5EF4-FFF2-40B4-BE49-F238E27FC236}">
                <a16:creationId xmlns:a16="http://schemas.microsoft.com/office/drawing/2014/main" id="{5A82646E-3381-E396-8148-9F3042404897}"/>
              </a:ext>
            </a:extLst>
          </p:cNvPr>
          <p:cNvSpPr txBox="1"/>
          <p:nvPr/>
        </p:nvSpPr>
        <p:spPr>
          <a:xfrm>
            <a:off x="845398" y="2219085"/>
            <a:ext cx="2792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C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B4D572A3-F13C-D02C-22BE-4AB550436559}"/>
              </a:ext>
            </a:extLst>
          </p:cNvPr>
          <p:cNvSpPr txBox="1"/>
          <p:nvPr/>
        </p:nvSpPr>
        <p:spPr>
          <a:xfrm>
            <a:off x="863032" y="3779193"/>
            <a:ext cx="26161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E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15076315-0E69-99D1-85A4-B4D8745E482E}"/>
              </a:ext>
            </a:extLst>
          </p:cNvPr>
          <p:cNvSpPr txBox="1"/>
          <p:nvPr/>
        </p:nvSpPr>
        <p:spPr>
          <a:xfrm>
            <a:off x="3477710" y="2219797"/>
            <a:ext cx="2792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D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69F89C3-1D32-EF79-90FA-418DD0586200}"/>
              </a:ext>
            </a:extLst>
          </p:cNvPr>
          <p:cNvSpPr txBox="1"/>
          <p:nvPr/>
        </p:nvSpPr>
        <p:spPr>
          <a:xfrm>
            <a:off x="856620" y="658978"/>
            <a:ext cx="2680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F984D7ED-7CF2-783E-2738-489CE6061242}"/>
              </a:ext>
            </a:extLst>
          </p:cNvPr>
          <p:cNvSpPr txBox="1"/>
          <p:nvPr/>
        </p:nvSpPr>
        <p:spPr>
          <a:xfrm>
            <a:off x="3488932" y="660401"/>
            <a:ext cx="2680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B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8DBEE50-B86F-405C-E852-1FA18BC0362A}"/>
              </a:ext>
            </a:extLst>
          </p:cNvPr>
          <p:cNvSpPr txBox="1"/>
          <p:nvPr/>
        </p:nvSpPr>
        <p:spPr>
          <a:xfrm>
            <a:off x="3500152" y="3779193"/>
            <a:ext cx="25680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F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207BF825-EBC1-E670-A53E-8BD9E93928F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5002034" y="844950"/>
            <a:ext cx="996396" cy="39090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132B31B-F4D7-3130-740D-06CCA1D9983D}"/>
              </a:ext>
            </a:extLst>
          </p:cNvPr>
          <p:cNvSpPr txBox="1"/>
          <p:nvPr/>
        </p:nvSpPr>
        <p:spPr>
          <a:xfrm>
            <a:off x="342901" y="5502464"/>
            <a:ext cx="6172200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</a:pPr>
            <a:r>
              <a:rPr lang="en-US" sz="11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 E3.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Omalizumab reduces surface expression levels of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cɛRI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as well as HLA-DR, CCR7, and costimulatory molecules on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DCs</a:t>
            </a:r>
            <a:r>
              <a:rPr lang="en-US" sz="11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xpression levels of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cɛRI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(A), CCR7 (B), HLA-DR (C), CD80 (D), CD83 (E), and CD86 (F) on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DCs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(Lin-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-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HLA-DR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+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CD123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-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CD11c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+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)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in the blood of individual patients were assessed at weeks 0 and 26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Mean fluorescent intensity (MFI) values were acquired after subtracting MFI values of control antibodies. Wilcoxon matched-pairs signed rank test was used to test the difference between week 0 and 26 of responders or non-responders. *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&lt; 0.05, **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&lt; 0.01, ***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&lt; 0.001, ****P&lt;0.0001, and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n.s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: not significant. 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C72C4213-EC61-F758-37BB-3739260ABF6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7378" y="3692031"/>
            <a:ext cx="1828237" cy="173736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704C5018-5FCD-DA7C-2466-1E48038A0CF8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34557"/>
          <a:stretch/>
        </p:blipFill>
        <p:spPr>
          <a:xfrm>
            <a:off x="3590990" y="3694701"/>
            <a:ext cx="1710723" cy="173736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5C45398-DDD7-2098-1657-1D8A92DC3E5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94472" y="566810"/>
            <a:ext cx="1822891" cy="173736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AC95C5FB-6F6C-0C66-2EE9-83460502CD6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34917" y="2125210"/>
            <a:ext cx="1881695" cy="173736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9EB67F4-EF5E-212D-AD3B-2E7E3182C97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47498" y="2126011"/>
            <a:ext cx="1769434" cy="173736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62B7B41-25F7-61F4-0FD9-5AFE6E9C6DDA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5002034" y="2407845"/>
            <a:ext cx="996396" cy="39090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BB11C71-724A-BFDE-7B40-085F6C9500B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4999128" y="3969856"/>
            <a:ext cx="996396" cy="39090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22661F4-3FF2-2400-C16E-5C70771EDC0C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2402626" y="844950"/>
            <a:ext cx="996396" cy="39090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8EB139E0-90EA-23E6-EE1D-F89F8EB08CD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2402626" y="2407845"/>
            <a:ext cx="996396" cy="390904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C5FC6B21-DE50-E16D-EB01-BFA9568DA481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2402626" y="3969856"/>
            <a:ext cx="996396" cy="39090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CB1F5F0-8C0F-F7EB-ED50-17A145F8D4E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31550" y="562204"/>
            <a:ext cx="1887502" cy="17373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51661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609D174-EBB3-6138-E7EB-761E0F8D1F7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48">
            <a:extLst>
              <a:ext uri="{FF2B5EF4-FFF2-40B4-BE49-F238E27FC236}">
                <a16:creationId xmlns:a16="http://schemas.microsoft.com/office/drawing/2014/main" id="{C82FD829-F260-0274-EB22-53D0D38E5E0C}"/>
              </a:ext>
            </a:extLst>
          </p:cNvPr>
          <p:cNvSpPr txBox="1"/>
          <p:nvPr/>
        </p:nvSpPr>
        <p:spPr>
          <a:xfrm>
            <a:off x="853018" y="2219085"/>
            <a:ext cx="2792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C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62C4873-F5E4-5B6A-5AA5-9F03A602A42C}"/>
              </a:ext>
            </a:extLst>
          </p:cNvPr>
          <p:cNvSpPr txBox="1"/>
          <p:nvPr/>
        </p:nvSpPr>
        <p:spPr>
          <a:xfrm>
            <a:off x="870652" y="3779193"/>
            <a:ext cx="26161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E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90E1E49-2CD9-F2E5-66E4-9CDE0C7EC0D1}"/>
              </a:ext>
            </a:extLst>
          </p:cNvPr>
          <p:cNvSpPr txBox="1"/>
          <p:nvPr/>
        </p:nvSpPr>
        <p:spPr>
          <a:xfrm>
            <a:off x="3483425" y="2219797"/>
            <a:ext cx="2792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D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44F1AB63-F100-93A8-E86C-F1C0A1A86CD2}"/>
              </a:ext>
            </a:extLst>
          </p:cNvPr>
          <p:cNvSpPr txBox="1"/>
          <p:nvPr/>
        </p:nvSpPr>
        <p:spPr>
          <a:xfrm>
            <a:off x="864240" y="658978"/>
            <a:ext cx="2680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C279E5F-65D0-D4CF-2335-A49C3AE33871}"/>
              </a:ext>
            </a:extLst>
          </p:cNvPr>
          <p:cNvSpPr txBox="1"/>
          <p:nvPr/>
        </p:nvSpPr>
        <p:spPr>
          <a:xfrm>
            <a:off x="3494647" y="660401"/>
            <a:ext cx="2680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B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F9EF60C-7745-0F5C-51D5-CE5723D44F74}"/>
              </a:ext>
            </a:extLst>
          </p:cNvPr>
          <p:cNvSpPr txBox="1"/>
          <p:nvPr/>
        </p:nvSpPr>
        <p:spPr>
          <a:xfrm>
            <a:off x="3505867" y="3779193"/>
            <a:ext cx="25680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F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BB6B510B-2256-B6C6-D2D3-BF801DF49ED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4996319" y="844950"/>
            <a:ext cx="996396" cy="39090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0BDF494-8980-AF81-45E5-4251CEA8F710}"/>
              </a:ext>
            </a:extLst>
          </p:cNvPr>
          <p:cNvSpPr txBox="1"/>
          <p:nvPr/>
        </p:nvSpPr>
        <p:spPr>
          <a:xfrm>
            <a:off x="342900" y="5502464"/>
            <a:ext cx="6172200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</a:pPr>
            <a:r>
              <a:rPr lang="en-US" sz="11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 E4.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Omalizumab treatment decreases surface expression levels of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cɛRI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as well as HLA-DR, CCR7, and costimulatory molecules on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pDCs</a:t>
            </a:r>
            <a:r>
              <a:rPr lang="en-US" sz="11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rface expression levels of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cɛRI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(A), CCR7 (B), </a:t>
            </a:r>
            <a:r>
              <a:rPr lang="en-US" sz="11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HLA-DR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(C), CD80 (D), CD83 (E), and CD86 (F) on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pDCs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(Lin-1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-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HLA-DR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+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CD123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+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CD11c</a:t>
            </a:r>
            <a:r>
              <a:rPr lang="en-US" sz="1100" baseline="300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-</a:t>
            </a:r>
            <a:r>
              <a:rPr lang="en-US" sz="1100" dirty="0">
                <a:latin typeface="Times New Roman" panose="02020603050405020304" pitchFamily="18" charset="0"/>
                <a:ea typeface="Malgun Gothic" panose="020B0503020000020004" pitchFamily="34" charset="-127"/>
              </a:rPr>
              <a:t>)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in the blood of individual patients (responders and non-responders) were assessed at weeks 0 and 26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Mean fluorescent intensity (MFI) values were acquired after subtracting MFI values of control antibodies. Wilcoxon matched-pairs signed rank test was used to calculate significance between week 0 and 26 of responders or non-responders. *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&lt; 0.05, **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&lt; 0.01, ***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&lt; 0.001, ****P&lt;0.0001, and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n.s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: not significant. </a:t>
            </a:r>
            <a:endParaRPr lang="en-US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C4D2E706-3C3B-74A2-D17F-DEDF7FA07B6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73763" y="3697352"/>
            <a:ext cx="1839242" cy="173736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129878E-F6C9-AD74-1BE3-C1361C29EF1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32114" y="560071"/>
            <a:ext cx="1887502" cy="173736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686ABE6-71A6-76FA-E75D-3DA4E4A0A95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49659" y="2116710"/>
            <a:ext cx="1882140" cy="173736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E22DD28-44E9-DD8F-74CC-1748FB81666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01478" y="3699090"/>
            <a:ext cx="1833880" cy="173736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1C64221-A030-3DD6-3AFC-2F91F37FCFB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42097" y="2116091"/>
            <a:ext cx="1774896" cy="173736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16886371-DAB1-1E40-DB3E-CCE544D6EB1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5002034" y="2407845"/>
            <a:ext cx="996396" cy="390904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3B4F0A0-0536-6BD7-15B2-35A169A31E8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4999128" y="3969856"/>
            <a:ext cx="996396" cy="39090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828B8E3-92FA-E5FA-E952-F415BF259B6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2402626" y="844950"/>
            <a:ext cx="996396" cy="39090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696A4EB-277C-520F-A5CE-5B30C35F8F7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2402626" y="2407845"/>
            <a:ext cx="996396" cy="39090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06C36C4-1187-9751-E272-4758A57087D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2402626" y="3969856"/>
            <a:ext cx="996396" cy="390904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D38ECE46-A925-8C3B-1572-F6F2DEE89DE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03666" y="572014"/>
            <a:ext cx="1822892" cy="17373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63951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21896E97-C8DE-F9CC-55D8-148B513E0655}"/>
              </a:ext>
            </a:extLst>
          </p:cNvPr>
          <p:cNvSpPr txBox="1"/>
          <p:nvPr/>
        </p:nvSpPr>
        <p:spPr>
          <a:xfrm>
            <a:off x="2974" y="508563"/>
            <a:ext cx="2680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1A0E494-0F06-97EF-0C90-888014B0C92D}"/>
              </a:ext>
            </a:extLst>
          </p:cNvPr>
          <p:cNvSpPr txBox="1"/>
          <p:nvPr/>
        </p:nvSpPr>
        <p:spPr>
          <a:xfrm>
            <a:off x="-828" y="2447365"/>
            <a:ext cx="26642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cs typeface="Arial" panose="020B0604020202020204" pitchFamily="34" charset="0"/>
              </a:rPr>
              <a:t>B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63C9450-6537-5D94-A157-D2C18889FF00}"/>
              </a:ext>
            </a:extLst>
          </p:cNvPr>
          <p:cNvSpPr txBox="1"/>
          <p:nvPr/>
        </p:nvSpPr>
        <p:spPr>
          <a:xfrm>
            <a:off x="3340272" y="2447365"/>
            <a:ext cx="27764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cs typeface="Arial" panose="020B0604020202020204" pitchFamily="34" charset="0"/>
              </a:rPr>
              <a:t>C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DF7C055-D80A-FF11-4BAC-DE956DCE480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2307" t="1" r="33073" b="478"/>
          <a:stretch/>
        </p:blipFill>
        <p:spPr>
          <a:xfrm>
            <a:off x="5106680" y="2471347"/>
            <a:ext cx="1647669" cy="1691640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3C3AA6DA-0C19-57C9-A985-8A6C1E976E11}"/>
              </a:ext>
            </a:extLst>
          </p:cNvPr>
          <p:cNvSpPr txBox="1"/>
          <p:nvPr/>
        </p:nvSpPr>
        <p:spPr>
          <a:xfrm>
            <a:off x="36041" y="4252818"/>
            <a:ext cx="27764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cs typeface="Arial" panose="020B0604020202020204" pitchFamily="34" charset="0"/>
              </a:rPr>
              <a:t>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FF65B07-EC7C-20E4-5F61-596BB13997C1}"/>
              </a:ext>
            </a:extLst>
          </p:cNvPr>
          <p:cNvSpPr txBox="1"/>
          <p:nvPr/>
        </p:nvSpPr>
        <p:spPr>
          <a:xfrm>
            <a:off x="3340272" y="4252818"/>
            <a:ext cx="26161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cs typeface="Arial" panose="020B0604020202020204" pitchFamily="34" charset="0"/>
              </a:rPr>
              <a:t>E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DD9DF79E-469B-7C74-56A8-75295BB0A18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8879" r="34982"/>
          <a:stretch/>
        </p:blipFill>
        <p:spPr>
          <a:xfrm>
            <a:off x="5109700" y="4352685"/>
            <a:ext cx="1601305" cy="167335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9E9E4DFB-8476-5D6A-FCBF-27D9618E170D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70785" t="17424" b="64894"/>
          <a:stretch/>
        </p:blipFill>
        <p:spPr>
          <a:xfrm>
            <a:off x="1845342" y="429565"/>
            <a:ext cx="1066853" cy="36252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071A4F3-A99B-682F-5511-2971973038F8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69692" t="15895" b="63150"/>
          <a:stretch/>
        </p:blipFill>
        <p:spPr>
          <a:xfrm>
            <a:off x="699633" y="408171"/>
            <a:ext cx="1070855" cy="402336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CB3E60BC-02EC-75B5-9B90-451D616C6D86}"/>
              </a:ext>
            </a:extLst>
          </p:cNvPr>
          <p:cNvSpPr txBox="1"/>
          <p:nvPr/>
        </p:nvSpPr>
        <p:spPr>
          <a:xfrm>
            <a:off x="342900" y="6095483"/>
            <a:ext cx="6172200" cy="19697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 E5.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sthma patients have increased numbers of blood circulating CD14</a:t>
            </a:r>
            <a:r>
              <a:rPr lang="en-US" sz="110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monocytes. Baseline (week 0) numbers of total CD14</a:t>
            </a:r>
            <a:r>
              <a:rPr lang="en-US" sz="110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A), CD14</a:t>
            </a:r>
            <a:r>
              <a:rPr lang="en-US" sz="110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D16</a:t>
            </a:r>
            <a:r>
              <a:rPr lang="en-US" sz="110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-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B), CD14</a:t>
            </a:r>
            <a:r>
              <a:rPr lang="en-US" sz="110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D16</a:t>
            </a:r>
            <a:r>
              <a:rPr lang="en-US" sz="110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C), and CD14</a:t>
            </a:r>
            <a:r>
              <a:rPr lang="en-US" sz="110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dim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D16</a:t>
            </a:r>
            <a:r>
              <a:rPr lang="en-US" sz="110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D), and CD14</a:t>
            </a:r>
            <a:r>
              <a:rPr lang="en-US" sz="110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D2</a:t>
            </a:r>
            <a:r>
              <a:rPr lang="en-US" sz="110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i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E) monocytes per </a:t>
            </a:r>
            <a:r>
              <a:rPr lang="en-US" sz="1100" kern="100" dirty="0">
                <a:effectLst/>
                <a:latin typeface="Symbol" panose="05050102010706020507" pitchFamily="18" charset="2"/>
                <a:ea typeface="Aptos" panose="020B0004020202020204" pitchFamily="34" charset="0"/>
                <a:cs typeface="Times New Roman" panose="02020603050405020304" pitchFamily="18" charset="0"/>
              </a:rPr>
              <a:t>m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L of blood from non-asthmatic control subjects and asthma patients were compared (left panels in A-E). The numbers of individual monocyte subsets per </a:t>
            </a:r>
            <a:r>
              <a:rPr lang="en-US" sz="1100" kern="100" dirty="0">
                <a:effectLst/>
                <a:latin typeface="Symbol" panose="05050102010706020507" pitchFamily="18" charset="2"/>
                <a:ea typeface="Aptos" panose="020B0004020202020204" pitchFamily="34" charset="0"/>
                <a:cs typeface="Times New Roman" panose="02020603050405020304" pitchFamily="18" charset="0"/>
              </a:rPr>
              <a:t>m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L of blood in all asthma patients are also measured at indicated time points (left panels).  Right panels in A-E present the numbers of individual monocyte subsets in omalizumab responders and non-responders at indicated time points. Mann-Whitney U test was used to test the difference between control subjects and asthma patients. Wilcoxon matched-pairs signed rank test was used to test differences between week 0 and 26 of responders or non-responders. Data are expressed as Tukey-style box plots, with boxes binding IQR divided by the median. *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&lt; 0.05, **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&lt; 0.01, ***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&lt; 0.001, ****P&lt;0.0001, and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n.s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: not significant. </a:t>
            </a:r>
            <a:endParaRPr lang="en-US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</a:pPr>
            <a:endParaRPr lang="en-US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5661561F-F123-E43D-E41C-B22B1E64DFD0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3959" r="28566"/>
          <a:stretch/>
        </p:blipFill>
        <p:spPr>
          <a:xfrm>
            <a:off x="1830464" y="488447"/>
            <a:ext cx="1805996" cy="173736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F88EC424-0CAD-CB2C-DEF1-679FDC8E272C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13898" r="27944"/>
          <a:stretch/>
        </p:blipFill>
        <p:spPr>
          <a:xfrm>
            <a:off x="1829019" y="2488820"/>
            <a:ext cx="1773880" cy="169164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D27666B5-0D42-6F90-A515-EFFA04D1E840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12224" r="28935"/>
          <a:stretch/>
        </p:blipFill>
        <p:spPr>
          <a:xfrm>
            <a:off x="1829019" y="4337362"/>
            <a:ext cx="1776054" cy="170078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857E8CC-461C-DA8C-0EA4-61D343D9F35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25429" y="490153"/>
            <a:ext cx="1961880" cy="173736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F66E921C-2E03-3AFF-B726-DAC66057AD5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31677" y="2628446"/>
            <a:ext cx="1913206" cy="155448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6D04DE3D-F86F-B55F-3876-11BAC67065A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445047" y="2591246"/>
            <a:ext cx="1909019" cy="1581912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BA4D6679-4493-905D-4CC2-F827AAF9B7C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00412" y="4471739"/>
            <a:ext cx="1849831" cy="155448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CEB959BF-1303-BCED-7A96-7DF1B5566F1A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575852" y="4331095"/>
            <a:ext cx="1753116" cy="1700784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7AC87C4F-14FB-A9AC-3A74-69A226DAEF14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70785" t="17424" b="64894"/>
          <a:stretch/>
        </p:blipFill>
        <p:spPr>
          <a:xfrm>
            <a:off x="1845342" y="2286940"/>
            <a:ext cx="1066853" cy="362529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072CA8EA-4CFA-5F3B-2287-39705AAA4FAC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69692" t="15895" b="63150"/>
          <a:stretch/>
        </p:blipFill>
        <p:spPr>
          <a:xfrm>
            <a:off x="699633" y="2265546"/>
            <a:ext cx="1070855" cy="402336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AC3E7C98-DDFE-41B6-59BE-CB02D0182D9F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70785" t="17424" b="64894"/>
          <a:stretch/>
        </p:blipFill>
        <p:spPr>
          <a:xfrm>
            <a:off x="5112417" y="2286940"/>
            <a:ext cx="1066853" cy="362529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B71F2FF1-2434-A6D6-5D18-10528C0CA348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69692" t="15895" b="63150"/>
          <a:stretch/>
        </p:blipFill>
        <p:spPr>
          <a:xfrm>
            <a:off x="3966708" y="2265546"/>
            <a:ext cx="1070855" cy="402336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47C768A0-2A30-4BDF-3993-C4EE9B9F6862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70785" t="17424" b="64894"/>
          <a:stretch/>
        </p:blipFill>
        <p:spPr>
          <a:xfrm>
            <a:off x="1845342" y="4287190"/>
            <a:ext cx="1066853" cy="362529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8BD13789-EBF6-D122-E599-D870F7372CBA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69692" t="15895" b="63150"/>
          <a:stretch/>
        </p:blipFill>
        <p:spPr>
          <a:xfrm>
            <a:off x="699633" y="4265796"/>
            <a:ext cx="1070855" cy="402336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54C99FBA-C817-DBDB-0732-516BE2B19F1D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70785" t="17424" b="64894"/>
          <a:stretch/>
        </p:blipFill>
        <p:spPr>
          <a:xfrm>
            <a:off x="5112417" y="4287190"/>
            <a:ext cx="1066853" cy="362529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B67FE296-B655-27EA-34E2-0AEEB2D7B8FA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69692" t="15895" b="63150"/>
          <a:stretch/>
        </p:blipFill>
        <p:spPr>
          <a:xfrm>
            <a:off x="3966708" y="4265796"/>
            <a:ext cx="1070855" cy="4023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73371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168B686-3968-9BB3-2DDB-3BF5C2CA976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48">
            <a:extLst>
              <a:ext uri="{FF2B5EF4-FFF2-40B4-BE49-F238E27FC236}">
                <a16:creationId xmlns:a16="http://schemas.microsoft.com/office/drawing/2014/main" id="{181DEEDE-DD3A-ACC2-CD32-AC8D578DFB84}"/>
              </a:ext>
            </a:extLst>
          </p:cNvPr>
          <p:cNvSpPr txBox="1"/>
          <p:nvPr/>
        </p:nvSpPr>
        <p:spPr>
          <a:xfrm>
            <a:off x="816823" y="2219085"/>
            <a:ext cx="2792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C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32AF606-ED67-30DA-633A-AA3CF8331E07}"/>
              </a:ext>
            </a:extLst>
          </p:cNvPr>
          <p:cNvSpPr txBox="1"/>
          <p:nvPr/>
        </p:nvSpPr>
        <p:spPr>
          <a:xfrm>
            <a:off x="3449135" y="2219797"/>
            <a:ext cx="2792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D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7C6E9F4-D5ED-33E2-C0A2-8BD3021FE6A9}"/>
              </a:ext>
            </a:extLst>
          </p:cNvPr>
          <p:cNvSpPr txBox="1"/>
          <p:nvPr/>
        </p:nvSpPr>
        <p:spPr>
          <a:xfrm>
            <a:off x="828045" y="658978"/>
            <a:ext cx="2680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62F4D765-8C11-6F21-CA04-FAF454D9BF80}"/>
              </a:ext>
            </a:extLst>
          </p:cNvPr>
          <p:cNvSpPr txBox="1"/>
          <p:nvPr/>
        </p:nvSpPr>
        <p:spPr>
          <a:xfrm>
            <a:off x="3460357" y="660401"/>
            <a:ext cx="2680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B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E9E58F9A-D882-280E-D512-0039EE675C2A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4954409" y="844950"/>
            <a:ext cx="996396" cy="39090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4BA82F4-CC65-5069-F9EB-42E27A325B42}"/>
              </a:ext>
            </a:extLst>
          </p:cNvPr>
          <p:cNvSpPr txBox="1"/>
          <p:nvPr/>
        </p:nvSpPr>
        <p:spPr>
          <a:xfrm>
            <a:off x="342900" y="4026089"/>
            <a:ext cx="6172200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</a:pPr>
            <a:r>
              <a:rPr lang="en-US" sz="11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 E6.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Omalizumab decreases surface expression levels of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cɛRI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as well as CCR7, HLA-DR, and CD88 on CD14</a:t>
            </a:r>
            <a:r>
              <a:rPr lang="en-US" sz="1100" kern="100" baseline="30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+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D16</a:t>
            </a:r>
            <a:r>
              <a:rPr lang="en-US" sz="1100" kern="100" baseline="30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-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blood monocyte in asthma patients.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Whole blood were stained and the expression levels of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cɛRI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(A), CCR7 (B), HLA-DR (C), and CD88 (D) at baseline (week 0) and after anti-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gE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treatment (week 26) in responders and non-responders were assessed by flow cytometry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Mean fluorescent intensity (MFI) values were acquired after subtracting MFI values of control antibodies. Wilcoxon matched-pairs signed rank test was used to test differences between week 0 and 26 of responders or non-responders. *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&lt; 0.05, **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&lt; 0.01, ***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&lt; 0.001, ****P&lt;0.0001, and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n.s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: not significant.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827AC18-83C8-A9FB-D7E2-8BEC9B5623F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54035" y="2099926"/>
            <a:ext cx="1828237" cy="173736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182D3AF-AAEC-CBDF-5F6E-1643295774C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63725" y="564700"/>
            <a:ext cx="1828237" cy="173736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D7B0F9A-C79F-6990-72C8-C85E2BE08D3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59623" y="2099926"/>
            <a:ext cx="1828237" cy="173736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BA17FA4F-26AF-1B46-C214-E344109F051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71704" y="569002"/>
            <a:ext cx="1822892" cy="173736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45EDED08-CB08-D0B1-91CD-3C8EF4FB65C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4963934" y="2407845"/>
            <a:ext cx="996396" cy="390904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848CBE4-AB34-2508-2659-FB427369B8EC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2364526" y="844950"/>
            <a:ext cx="996396" cy="390904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75736629-EA99-056A-81A6-D291614C7BB1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2364526" y="2407845"/>
            <a:ext cx="996396" cy="3909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916884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6CB983F-433C-2C5C-CC99-82350891D58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48">
            <a:extLst>
              <a:ext uri="{FF2B5EF4-FFF2-40B4-BE49-F238E27FC236}">
                <a16:creationId xmlns:a16="http://schemas.microsoft.com/office/drawing/2014/main" id="{61B51878-06DA-D74B-AE69-233523FB335C}"/>
              </a:ext>
            </a:extLst>
          </p:cNvPr>
          <p:cNvSpPr txBox="1"/>
          <p:nvPr/>
        </p:nvSpPr>
        <p:spPr>
          <a:xfrm>
            <a:off x="816823" y="2219085"/>
            <a:ext cx="2792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C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CD6DC4E-EE8B-442F-24A4-4FD8C9076429}"/>
              </a:ext>
            </a:extLst>
          </p:cNvPr>
          <p:cNvSpPr txBox="1"/>
          <p:nvPr/>
        </p:nvSpPr>
        <p:spPr>
          <a:xfrm>
            <a:off x="3449135" y="2219797"/>
            <a:ext cx="2792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D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9CBF3DB-4E58-49F1-40AD-D9584FEBA29E}"/>
              </a:ext>
            </a:extLst>
          </p:cNvPr>
          <p:cNvSpPr txBox="1"/>
          <p:nvPr/>
        </p:nvSpPr>
        <p:spPr>
          <a:xfrm>
            <a:off x="828045" y="658978"/>
            <a:ext cx="2680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EE09A0B-20C1-409E-A164-6E552DCD53B7}"/>
              </a:ext>
            </a:extLst>
          </p:cNvPr>
          <p:cNvSpPr txBox="1"/>
          <p:nvPr/>
        </p:nvSpPr>
        <p:spPr>
          <a:xfrm>
            <a:off x="3460357" y="660401"/>
            <a:ext cx="2680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B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7F764822-5359-6179-85F9-BDB32714110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4954409" y="844950"/>
            <a:ext cx="996396" cy="39090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D47B12E-EC35-F524-22FB-69A1E6822488}"/>
              </a:ext>
            </a:extLst>
          </p:cNvPr>
          <p:cNvSpPr txBox="1"/>
          <p:nvPr/>
        </p:nvSpPr>
        <p:spPr>
          <a:xfrm>
            <a:off x="342901" y="4026089"/>
            <a:ext cx="6172200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</a:pPr>
            <a:r>
              <a:rPr lang="en-US" sz="11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 E</a:t>
            </a:r>
            <a:r>
              <a:rPr lang="en-US" sz="1100" b="1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7</a:t>
            </a:r>
            <a:r>
              <a:rPr lang="en-US" sz="11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Omalizumab decreases surface expression levels of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cɛRI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as well as CCR7, HLA-DR, and CD88 on CD14</a:t>
            </a:r>
            <a:r>
              <a:rPr lang="en-US" sz="1100" kern="100" baseline="30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+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D16</a:t>
            </a:r>
            <a:r>
              <a:rPr lang="en-US" sz="1100" kern="1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+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blood monocyte in asthma patients.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Whole blood were stained and the expression levels of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cɛRI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(A), CCR7 (B), HLA-DR (C), and CD88 (D) at baseline (week 0) and after anti-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gE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treatment (week 26) in responders and non-responders are assessed by flowcytometry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Mean fluorescent intensity (MFI) values were acquired after subtracting MFI values of control antibodies. Wilcoxon matched-pairs signed rank test was used to test differences between week 0 and 26 of responders or non-responders. *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&lt; 0.05, **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&lt; 0.01, ***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&lt; 0.001, ****P&lt;0.0001, and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n.s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: not significant. 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2958A903-0430-E56C-B9A1-2E5E214200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92725" y="2081104"/>
            <a:ext cx="1887040" cy="173736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7CFDEC46-ECDA-74B3-EE35-5AE821BC02C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61081" y="566953"/>
            <a:ext cx="1833583" cy="173736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41686E8-9695-2704-E9E9-633A84B6EE7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34422" y="2069151"/>
            <a:ext cx="1814691" cy="173736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D4BAA89-FEA5-25EB-0E73-75E14C82809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51986" y="571881"/>
            <a:ext cx="1833583" cy="173736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393928B3-412B-ED1A-632D-3AFC8E1EB2EA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4963934" y="2407845"/>
            <a:ext cx="996396" cy="390904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37EF07E-E746-58CA-5880-60BE22B6D0DC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2364526" y="844950"/>
            <a:ext cx="996396" cy="390904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6EC0D068-3E9E-A8BE-B4E8-45164D367115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2364526" y="2407845"/>
            <a:ext cx="996396" cy="3909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7412871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E76E91A-71E7-6863-6EAA-ED5B3D93403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48">
            <a:extLst>
              <a:ext uri="{FF2B5EF4-FFF2-40B4-BE49-F238E27FC236}">
                <a16:creationId xmlns:a16="http://schemas.microsoft.com/office/drawing/2014/main" id="{12BA96E3-C530-EFEF-7BD4-893AF4A84533}"/>
              </a:ext>
            </a:extLst>
          </p:cNvPr>
          <p:cNvSpPr txBox="1"/>
          <p:nvPr/>
        </p:nvSpPr>
        <p:spPr>
          <a:xfrm>
            <a:off x="816823" y="2219085"/>
            <a:ext cx="2792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C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9310B22-AA3A-80F0-D85F-D99499330301}"/>
              </a:ext>
            </a:extLst>
          </p:cNvPr>
          <p:cNvSpPr txBox="1"/>
          <p:nvPr/>
        </p:nvSpPr>
        <p:spPr>
          <a:xfrm>
            <a:off x="3442785" y="2219797"/>
            <a:ext cx="2792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D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A27E220-2C72-89D3-E795-D747E91A8265}"/>
              </a:ext>
            </a:extLst>
          </p:cNvPr>
          <p:cNvSpPr txBox="1"/>
          <p:nvPr/>
        </p:nvSpPr>
        <p:spPr>
          <a:xfrm>
            <a:off x="828045" y="658978"/>
            <a:ext cx="2680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B69465E-BDF2-F98F-0EB4-0844221BB303}"/>
              </a:ext>
            </a:extLst>
          </p:cNvPr>
          <p:cNvSpPr txBox="1"/>
          <p:nvPr/>
        </p:nvSpPr>
        <p:spPr>
          <a:xfrm>
            <a:off x="3454007" y="660401"/>
            <a:ext cx="2680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B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7CA2665F-C10C-C98B-4556-9204A775CE05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4948059" y="844950"/>
            <a:ext cx="996396" cy="39090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C3F5D7B-0BF0-8EC2-8DDC-090FC08C2AE7}"/>
              </a:ext>
            </a:extLst>
          </p:cNvPr>
          <p:cNvSpPr txBox="1"/>
          <p:nvPr/>
        </p:nvSpPr>
        <p:spPr>
          <a:xfrm>
            <a:off x="342900" y="4026089"/>
            <a:ext cx="6172199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</a:pPr>
            <a:r>
              <a:rPr lang="en-US" sz="11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 E8.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Omalizumab decreases surface expression levels of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HLA-DR and CD88 on CD14</a:t>
            </a:r>
            <a:r>
              <a:rPr lang="en-US" sz="1100" kern="1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im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D16</a:t>
            </a:r>
            <a:r>
              <a:rPr lang="en-US" sz="1100" kern="1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+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blood monocyte in asthma patients.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Whole blood were stained and the expression levels of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cɛRI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(A), CCR7 (B), HLA-DR (C), and CD88 (D) at baseline (week 0) and after anti-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gE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treatment (week 26) in responders and non-responders are assessed by flowcytometry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Mean fluorescent intensity (MFI) values were acquired after subtracting MFI values of control antibodies. Wilcoxon matched-pairs signed rank test was used to test differences between week 0 and 26 of responders or non-responders. *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&lt; 0.05, **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&lt; 0.01, ***</a:t>
            </a:r>
            <a:r>
              <a:rPr lang="en-US" sz="11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&lt; 0.001, ****P&lt;0.0001, and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n.s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: not significant.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B677A2A-3D46-B89B-CB2D-3407420387E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1384" y="2100490"/>
            <a:ext cx="1887040" cy="173736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FCB4694-BE72-D915-62D1-843A66DA21B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50369" y="564982"/>
            <a:ext cx="1822892" cy="173736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F9CBB3A-61B8-4B54-47C1-45456B5FC61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20023" y="2078531"/>
            <a:ext cx="1793240" cy="173736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273D7B45-72DC-D552-AB16-BE0C3E02D4A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63737" y="566437"/>
            <a:ext cx="1833583" cy="173736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9181ADE8-4DFF-6691-B120-061D742CEC2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4963934" y="2407845"/>
            <a:ext cx="996396" cy="39090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1CA46A03-BFCC-214E-FF0B-E138B269E29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2364526" y="844950"/>
            <a:ext cx="996396" cy="390904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239FA4F-1F82-9909-142B-8FF1590E7AC1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1883" t="14875" b="62625"/>
          <a:stretch/>
        </p:blipFill>
        <p:spPr>
          <a:xfrm>
            <a:off x="2364526" y="2407845"/>
            <a:ext cx="996396" cy="3909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9545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929</TotalTime>
  <Words>1580</Words>
  <Application>Microsoft Office PowerPoint</Application>
  <PresentationFormat>On-screen Show (4:3)</PresentationFormat>
  <Paragraphs>80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7" baseType="lpstr">
      <vt:lpstr>Aptos</vt:lpstr>
      <vt:lpstr>Aptos Display</vt:lpstr>
      <vt:lpstr>Arial</vt:lpstr>
      <vt:lpstr>Calibri</vt:lpstr>
      <vt:lpstr>Symbol</vt:lpstr>
      <vt:lpstr>Times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ng, Agnes</dc:creator>
  <cp:lastModifiedBy>Oh, SangKon, Ph.D.</cp:lastModifiedBy>
  <cp:revision>1061</cp:revision>
  <cp:lastPrinted>2024-12-13T18:10:04Z</cp:lastPrinted>
  <dcterms:created xsi:type="dcterms:W3CDTF">2024-07-19T21:44:25Z</dcterms:created>
  <dcterms:modified xsi:type="dcterms:W3CDTF">2025-03-28T15:56:51Z</dcterms:modified>
</cp:coreProperties>
</file>